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4" r:id="rId2"/>
    <p:sldId id="28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4660"/>
  </p:normalViewPr>
  <p:slideViewPr>
    <p:cSldViewPr snapToGrid="0">
      <p:cViewPr varScale="1">
        <p:scale>
          <a:sx n="64" d="100"/>
          <a:sy n="64" d="100"/>
        </p:scale>
        <p:origin x="758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5E57-66E6-45E4-A3B8-AA905289C374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FD57B7-1820-4D10-BB9A-353DA2A5F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624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C5DA6-9D36-B780-FBED-CC89880EC7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BE429E-E2D4-0B32-3233-6A0DF762EE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0C6240-AE6E-9F8B-362A-274AE32D3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3810F3-27ED-51B2-C216-7293FE1B3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E61A9-2D21-8AB3-6B4B-F724FD36E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515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03384-89FA-C161-B9BA-B82F67938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AE8912-CF1F-8887-5F6B-EEE5E4D472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A071E-5E57-9E8C-B470-058F54615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90C6A2-3891-41ED-82A0-A8481E6DF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CA0E52-F215-C309-1973-A715E930E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541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4A6467-0490-A465-8639-DECFF517EB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30FED1-ED84-FE46-BA49-DABBEC8EC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0DD362-EEE4-8EA7-4A26-FDD1902C3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3D1A7B-38DE-3F4E-78CD-7CF5DA426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A8650F-D3CA-CE92-DDEF-F275E699E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935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CD5AC-10BB-095C-F72D-2BB55EEC19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4F7FD0-21F4-740F-A26D-A906A72691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BC560-CBCD-F5F7-0ADC-D0DA6CF31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EA047-A8A9-C4CB-1D73-8AA559348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B87084-D01C-B657-0297-801D52191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779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2E453-FD70-7A1B-9EE1-D4112EBCE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644701-C6E0-F071-91C0-AABEDDFBF7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85565-CA1F-8CE2-4820-65D2FB9C7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6347F2-E8D8-DB1E-D862-28B2C5605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43B74E-1DF6-05E8-4D20-9FB00442E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327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7006F-FCEE-37D1-86F8-D4741F324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383CA1-435E-CF9C-6CC9-FDD3ED8379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A09941-6AAE-B5E3-6EE2-34CA502ED4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FEF03A-7982-B243-8B50-85FCA4E33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CBDE3A-11C6-6202-8187-E29DD285A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AA9440-46A5-0DA4-96CA-5892BB2A8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107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7F62D-56D3-55E6-BA50-6AF53B4D2A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6D2F69-1982-C853-5B8C-A6EC550CF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E84685-8ABB-C718-722E-4D2BB5D2A3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18E6BB-F658-2A28-AEA8-DA427A1923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E28244-E717-5779-1304-8C5DB8FC33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07835B-CA3F-06C0-8728-0FB804BF5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CF9DD3-8D3A-BF98-2D89-67ED1E63C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EB6E39-12E6-D4BD-2C33-1996243EA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443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4CA23-E10F-B439-CC93-E61DE8A98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061A43-E08C-D834-26D0-EA25C4793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FAE4D0-5C40-E9DD-8C44-647282BBD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DD6DFC-4533-5C58-43C2-A470B410B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020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512C9B-FD2C-95F8-085B-7D6517365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29C101-E483-B19E-396B-D4810AC9A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05309F-5EC5-4CF1-13CC-1A4315898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215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02279-004A-2162-C86E-7129DFB47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4992F5-E387-EAD8-C6B0-99B2A34D6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571441-E241-96B4-986E-C46A670A3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0CF38E-074A-9E04-6763-3813E1FF1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E74D9-4A35-3FAE-6958-60DABB817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C57559-6DA2-0AFD-37CA-9C027875B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529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F833D-5BD1-4402-53B5-0CA949463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E9A6C4-EB5B-5C89-225E-C5E3471437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040CA6-CA2F-9039-7992-7E6F5EC442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27352-DB06-5A49-51D1-CE147EE88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D71264-02F7-BE49-3C98-95739EB34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6E6F7F-C561-A456-7961-E674CA890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928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E728FC-D5D9-4C62-0E39-70D2631C6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8D08C1-F0A4-9DB1-7061-ABE5D71F7E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102C2-4425-9876-0583-0988BD6997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84BF5-9059-4BE4-AC40-3B83549252AE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37B1-3326-4C24-D824-D3CC3B5E1D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84786-17F7-FED5-E6E3-BCA86586F1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9E8B0-C566-45D3-9527-E76DDBEB5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942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DFFF904B-D401-B0D1-1089-13654BB79CB2}"/>
              </a:ext>
            </a:extLst>
          </p:cNvPr>
          <p:cNvSpPr txBox="1"/>
          <p:nvPr/>
        </p:nvSpPr>
        <p:spPr>
          <a:xfrm>
            <a:off x="527326" y="26927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BD065F-5ACA-0F07-BFF5-8677E70341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8" t="11370" r="23528" b="39099"/>
          <a:stretch/>
        </p:blipFill>
        <p:spPr>
          <a:xfrm>
            <a:off x="376" y="0"/>
            <a:ext cx="5806159" cy="339687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F3CA15F-E5BC-C2E7-B932-510D1BAFCE90}"/>
              </a:ext>
            </a:extLst>
          </p:cNvPr>
          <p:cNvSpPr txBox="1"/>
          <p:nvPr/>
        </p:nvSpPr>
        <p:spPr>
          <a:xfrm>
            <a:off x="2520024" y="1440751"/>
            <a:ext cx="11185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ll patien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44C582B-8EBB-4CE4-999C-FF2A60FA083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6" t="10469" r="27210" b="38732"/>
          <a:stretch/>
        </p:blipFill>
        <p:spPr>
          <a:xfrm>
            <a:off x="6486958" y="-14027"/>
            <a:ext cx="5256397" cy="348369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20054C1-5D7E-1E4C-CCB3-12A7F6AB8380}"/>
              </a:ext>
            </a:extLst>
          </p:cNvPr>
          <p:cNvSpPr txBox="1"/>
          <p:nvPr/>
        </p:nvSpPr>
        <p:spPr>
          <a:xfrm>
            <a:off x="0" y="-2659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864DEA2-0E65-CB45-FF99-278A94C3CD96}"/>
              </a:ext>
            </a:extLst>
          </p:cNvPr>
          <p:cNvSpPr txBox="1"/>
          <p:nvPr/>
        </p:nvSpPr>
        <p:spPr>
          <a:xfrm>
            <a:off x="8433499" y="1274797"/>
            <a:ext cx="23079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atients with narrow QR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8FB5D7-27DD-9ADF-6079-23B3F1B70CD3}"/>
              </a:ext>
            </a:extLst>
          </p:cNvPr>
          <p:cNvSpPr txBox="1"/>
          <p:nvPr/>
        </p:nvSpPr>
        <p:spPr>
          <a:xfrm>
            <a:off x="6154891" y="37118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A768375-66B7-34BD-C14E-A781C01767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4" t="10797" r="27278" b="41023"/>
          <a:stretch/>
        </p:blipFill>
        <p:spPr>
          <a:xfrm>
            <a:off x="302135" y="3284548"/>
            <a:ext cx="5301277" cy="330418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B7441F6-5B64-FC96-8FE1-9C32EA5AB2A3}"/>
              </a:ext>
            </a:extLst>
          </p:cNvPr>
          <p:cNvSpPr txBox="1"/>
          <p:nvPr/>
        </p:nvSpPr>
        <p:spPr>
          <a:xfrm>
            <a:off x="2043839" y="4580407"/>
            <a:ext cx="2110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atients with wide QR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C2941C-E63D-EF80-E28B-8C3F01A6D145}"/>
              </a:ext>
            </a:extLst>
          </p:cNvPr>
          <p:cNvSpPr txBox="1"/>
          <p:nvPr/>
        </p:nvSpPr>
        <p:spPr>
          <a:xfrm>
            <a:off x="522651" y="34397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91E160-C8AD-06C7-7E86-E398F6AF6BE4}"/>
              </a:ext>
            </a:extLst>
          </p:cNvPr>
          <p:cNvSpPr txBox="1"/>
          <p:nvPr/>
        </p:nvSpPr>
        <p:spPr>
          <a:xfrm>
            <a:off x="512358" y="29919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C729DBB-D1D9-8CCA-473E-FCD97E93FE9A}"/>
              </a:ext>
            </a:extLst>
          </p:cNvPr>
          <p:cNvSpPr txBox="1"/>
          <p:nvPr/>
        </p:nvSpPr>
        <p:spPr>
          <a:xfrm>
            <a:off x="3853942" y="29172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40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A31D39-55FE-10BE-FCFD-9D2C4D0A907F}"/>
              </a:ext>
            </a:extLst>
          </p:cNvPr>
          <p:cNvSpPr txBox="1"/>
          <p:nvPr/>
        </p:nvSpPr>
        <p:spPr>
          <a:xfrm>
            <a:off x="10102362" y="22897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49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85F8C6-EBD1-8F94-5671-76CDAA0FA53E}"/>
              </a:ext>
            </a:extLst>
          </p:cNvPr>
          <p:cNvSpPr txBox="1"/>
          <p:nvPr/>
        </p:nvSpPr>
        <p:spPr>
          <a:xfrm>
            <a:off x="3839004" y="342041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74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82FC1E7-2181-BFF2-1B8C-56D73AF007DF}"/>
              </a:ext>
            </a:extLst>
          </p:cNvPr>
          <p:cNvSpPr txBox="1"/>
          <p:nvPr/>
        </p:nvSpPr>
        <p:spPr>
          <a:xfrm>
            <a:off x="5283670" y="4466223"/>
            <a:ext cx="6866495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gend: </a:t>
            </a:r>
          </a:p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justed survival curves demonstrating no difference in the occurrence</a:t>
            </a:r>
          </a:p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mortality in patients with and without PR prolongation. </a:t>
            </a:r>
          </a:p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All patients;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Patients with narrow QRS;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Patients with wide QR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0796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789DBABF-15E9-2692-A1C0-C9F3472C80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15" t="9721" r="24733" b="39992"/>
          <a:stretch/>
        </p:blipFill>
        <p:spPr>
          <a:xfrm>
            <a:off x="-17928" y="3408145"/>
            <a:ext cx="5692747" cy="344866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B7441F6-5B64-FC96-8FE1-9C32EA5AB2A3}"/>
              </a:ext>
            </a:extLst>
          </p:cNvPr>
          <p:cNvSpPr txBox="1"/>
          <p:nvPr/>
        </p:nvSpPr>
        <p:spPr>
          <a:xfrm>
            <a:off x="2043839" y="4406503"/>
            <a:ext cx="2110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atients with wide QR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C2941C-E63D-EF80-E28B-8C3F01A6D145}"/>
              </a:ext>
            </a:extLst>
          </p:cNvPr>
          <p:cNvSpPr txBox="1"/>
          <p:nvPr/>
        </p:nvSpPr>
        <p:spPr>
          <a:xfrm>
            <a:off x="522651" y="34397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67EBFAD-4367-07AD-6148-A44AD23C41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4" t="19434" r="7484" b="29673"/>
          <a:stretch/>
        </p:blipFill>
        <p:spPr>
          <a:xfrm>
            <a:off x="107572" y="95619"/>
            <a:ext cx="5295154" cy="34902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39E8C6B-B7E2-8357-C819-C5F5A1FC9A00}"/>
              </a:ext>
            </a:extLst>
          </p:cNvPr>
          <p:cNvSpPr txBox="1"/>
          <p:nvPr/>
        </p:nvSpPr>
        <p:spPr>
          <a:xfrm>
            <a:off x="3868886" y="401804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38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0F9ECB-D631-BD23-FE34-59009846098F}"/>
              </a:ext>
            </a:extLst>
          </p:cNvPr>
          <p:cNvSpPr txBox="1"/>
          <p:nvPr/>
        </p:nvSpPr>
        <p:spPr>
          <a:xfrm>
            <a:off x="5217934" y="4466223"/>
            <a:ext cx="714009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gend: 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rvival curves demonstrating no difference in the occurrence</a:t>
            </a:r>
          </a:p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pacemaker implantation in patients with and without PR prolongation. </a:t>
            </a:r>
          </a:p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All patients;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Patients with narrow QRS;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Patients with wide QRS.</a:t>
            </a:r>
          </a:p>
          <a:p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F3CA15F-E5BC-C2E7-B932-510D1BAFCE90}"/>
              </a:ext>
            </a:extLst>
          </p:cNvPr>
          <p:cNvSpPr txBox="1"/>
          <p:nvPr/>
        </p:nvSpPr>
        <p:spPr>
          <a:xfrm>
            <a:off x="2520024" y="1244408"/>
            <a:ext cx="11185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ll patien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2F42B0-46DC-3EBE-13A9-78FE232E7B51}"/>
              </a:ext>
            </a:extLst>
          </p:cNvPr>
          <p:cNvSpPr txBox="1"/>
          <p:nvPr/>
        </p:nvSpPr>
        <p:spPr>
          <a:xfrm>
            <a:off x="3853942" y="50687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94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0054C1-5D7E-1E4C-CCB3-12A7F6AB8380}"/>
              </a:ext>
            </a:extLst>
          </p:cNvPr>
          <p:cNvSpPr txBox="1"/>
          <p:nvPr/>
        </p:nvSpPr>
        <p:spPr>
          <a:xfrm>
            <a:off x="0" y="-2659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FF904B-D401-B0D1-1089-13654BB79CB2}"/>
              </a:ext>
            </a:extLst>
          </p:cNvPr>
          <p:cNvSpPr txBox="1"/>
          <p:nvPr/>
        </p:nvSpPr>
        <p:spPr>
          <a:xfrm>
            <a:off x="476836" y="29732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70A151DB-01E5-5291-83C6-67D278B9238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3" t="8540" r="29954" b="38592"/>
          <a:stretch/>
        </p:blipFill>
        <p:spPr>
          <a:xfrm>
            <a:off x="6394827" y="47808"/>
            <a:ext cx="5414682" cy="362568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864DEA2-0E65-CB45-FF99-278A94C3CD96}"/>
              </a:ext>
            </a:extLst>
          </p:cNvPr>
          <p:cNvSpPr txBox="1"/>
          <p:nvPr/>
        </p:nvSpPr>
        <p:spPr>
          <a:xfrm>
            <a:off x="8292115" y="1151747"/>
            <a:ext cx="23079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atients with narrow QR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9F65D6-AE94-3617-6FAE-BA0DF630A4BB}"/>
              </a:ext>
            </a:extLst>
          </p:cNvPr>
          <p:cNvSpPr txBox="1"/>
          <p:nvPr/>
        </p:nvSpPr>
        <p:spPr>
          <a:xfrm>
            <a:off x="10329460" y="45607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=0.4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8FB5D7-27DD-9ADF-6079-23B3F1B70CD3}"/>
              </a:ext>
            </a:extLst>
          </p:cNvPr>
          <p:cNvSpPr txBox="1"/>
          <p:nvPr/>
        </p:nvSpPr>
        <p:spPr>
          <a:xfrm>
            <a:off x="6154891" y="37118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12470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2</TotalTime>
  <Words>127</Words>
  <Application>Microsoft Office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owitz, Yoav</dc:creator>
  <cp:lastModifiedBy>Yoav Michowitz</cp:lastModifiedBy>
  <cp:revision>36</cp:revision>
  <dcterms:created xsi:type="dcterms:W3CDTF">2023-06-03T13:02:18Z</dcterms:created>
  <dcterms:modified xsi:type="dcterms:W3CDTF">2024-01-02T04:52:57Z</dcterms:modified>
</cp:coreProperties>
</file>